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2" d="100"/>
          <a:sy n="72" d="100"/>
        </p:scale>
        <p:origin x="860" y="-2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__________Microsoft_Excel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__________Microsoft_Excel2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__________Microsoft_Excel3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__________Microsoft_Excel4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__________Microsoft_Excel5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package" Target="../embeddings/__________Microsoft_Excel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741498045113461"/>
          <c:y val="2.8326176428484819E-2"/>
          <c:w val="0.79538918868088526"/>
          <c:h val="0.8140643014343141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DPPH!$DD$56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4:$DA$74</c:f>
                <c:numCache>
                  <c:formatCode>General</c:formatCode>
                  <c:ptCount val="5"/>
                  <c:pt idx="0">
                    <c:v>1.2068603551717245</c:v>
                  </c:pt>
                  <c:pt idx="1">
                    <c:v>0.29501030904200387</c:v>
                  </c:pt>
                  <c:pt idx="2">
                    <c:v>2.0650721632938462</c:v>
                  </c:pt>
                  <c:pt idx="3">
                    <c:v>0.16091471402290666</c:v>
                  </c:pt>
                  <c:pt idx="4">
                    <c:v>8.0457357011448308E-2</c:v>
                  </c:pt>
                </c:numCache>
              </c:numRef>
            </c:plus>
            <c:minus>
              <c:numRef>
                <c:f>DPPH!$CW$74:$DA$74</c:f>
                <c:numCache>
                  <c:formatCode>General</c:formatCode>
                  <c:ptCount val="5"/>
                  <c:pt idx="0">
                    <c:v>1.2068603551717245</c:v>
                  </c:pt>
                  <c:pt idx="1">
                    <c:v>0.29501030904200387</c:v>
                  </c:pt>
                  <c:pt idx="2">
                    <c:v>2.0650721632938462</c:v>
                  </c:pt>
                  <c:pt idx="3">
                    <c:v>0.16091471402290666</c:v>
                  </c:pt>
                  <c:pt idx="4">
                    <c:v>8.045735701144830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E$55:$DI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E$56:$DI$56</c:f>
              <c:numCache>
                <c:formatCode>General</c:formatCode>
                <c:ptCount val="5"/>
                <c:pt idx="0">
                  <c:v>47.764285861142803</c:v>
                </c:pt>
                <c:pt idx="1">
                  <c:v>74.336953125989751</c:v>
                </c:pt>
                <c:pt idx="2">
                  <c:v>77.204166179661627</c:v>
                </c:pt>
                <c:pt idx="3">
                  <c:v>86.51330719648</c:v>
                </c:pt>
                <c:pt idx="4">
                  <c:v>91.63742511085727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3E59-46D7-A352-5C3B61C2D9AD}"/>
            </c:ext>
          </c:extLst>
        </c:ser>
        <c:ser>
          <c:idx val="1"/>
          <c:order val="1"/>
          <c:tx>
            <c:strRef>
              <c:f>DPPH!$DD$57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6:$DA$76</c:f>
                <c:numCache>
                  <c:formatCode>General</c:formatCode>
                  <c:ptCount val="5"/>
                  <c:pt idx="0">
                    <c:v>3.0841986854388952</c:v>
                  </c:pt>
                  <c:pt idx="1">
                    <c:v>6.5975032749388207</c:v>
                  </c:pt>
                  <c:pt idx="2">
                    <c:v>2.67654807658087</c:v>
                  </c:pt>
                  <c:pt idx="3">
                    <c:v>1.0995838791564769</c:v>
                  </c:pt>
                  <c:pt idx="4">
                    <c:v>0.53638238007630856</c:v>
                  </c:pt>
                </c:numCache>
              </c:numRef>
            </c:plus>
            <c:minus>
              <c:numRef>
                <c:f>DPPH!$CW$76:$DA$76</c:f>
                <c:numCache>
                  <c:formatCode>General</c:formatCode>
                  <c:ptCount val="5"/>
                  <c:pt idx="0">
                    <c:v>3.0841986854388952</c:v>
                  </c:pt>
                  <c:pt idx="1">
                    <c:v>6.5975032749388207</c:v>
                  </c:pt>
                  <c:pt idx="2">
                    <c:v>2.67654807658087</c:v>
                  </c:pt>
                  <c:pt idx="3">
                    <c:v>1.0995838791564769</c:v>
                  </c:pt>
                  <c:pt idx="4">
                    <c:v>0.536382380076308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E$55:$DI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E$57:$DI$57</c:f>
              <c:numCache>
                <c:formatCode>General</c:formatCode>
                <c:ptCount val="5"/>
                <c:pt idx="0">
                  <c:v>52.075091587228549</c:v>
                </c:pt>
                <c:pt idx="1">
                  <c:v>117.48375815442077</c:v>
                </c:pt>
                <c:pt idx="2">
                  <c:v>119.30240392398201</c:v>
                </c:pt>
                <c:pt idx="3">
                  <c:v>126.18632899541828</c:v>
                </c:pt>
                <c:pt idx="4">
                  <c:v>135.0425080818114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3E59-46D7-A352-5C3B61C2D9AD}"/>
            </c:ext>
          </c:extLst>
        </c:ser>
        <c:ser>
          <c:idx val="2"/>
          <c:order val="2"/>
          <c:tx>
            <c:strRef>
              <c:f>DPPH!$DD$58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6:$DA$76</c:f>
                <c:numCache>
                  <c:formatCode>General</c:formatCode>
                  <c:ptCount val="5"/>
                  <c:pt idx="0">
                    <c:v>3.0841986854388952</c:v>
                  </c:pt>
                  <c:pt idx="1">
                    <c:v>6.5975032749388207</c:v>
                  </c:pt>
                  <c:pt idx="2">
                    <c:v>2.67654807658087</c:v>
                  </c:pt>
                  <c:pt idx="3">
                    <c:v>1.0995838791564769</c:v>
                  </c:pt>
                  <c:pt idx="4">
                    <c:v>0.53638238007630856</c:v>
                  </c:pt>
                </c:numCache>
              </c:numRef>
            </c:plus>
            <c:minus>
              <c:numRef>
                <c:f>DPPH!$CW$76:$DA$76</c:f>
                <c:numCache>
                  <c:formatCode>General</c:formatCode>
                  <c:ptCount val="5"/>
                  <c:pt idx="0">
                    <c:v>3.0841986854388952</c:v>
                  </c:pt>
                  <c:pt idx="1">
                    <c:v>6.5975032749388207</c:v>
                  </c:pt>
                  <c:pt idx="2">
                    <c:v>2.67654807658087</c:v>
                  </c:pt>
                  <c:pt idx="3">
                    <c:v>1.0995838791564769</c:v>
                  </c:pt>
                  <c:pt idx="4">
                    <c:v>0.536382380076308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E$55:$DI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E$58:$DI$58</c:f>
              <c:numCache>
                <c:formatCode>General</c:formatCode>
                <c:ptCount val="5"/>
                <c:pt idx="0">
                  <c:v>52.075091587228549</c:v>
                </c:pt>
                <c:pt idx="1">
                  <c:v>111.73577553967606</c:v>
                </c:pt>
                <c:pt idx="2">
                  <c:v>120.95227026341718</c:v>
                </c:pt>
                <c:pt idx="3">
                  <c:v>128.36718680041875</c:v>
                </c:pt>
                <c:pt idx="4">
                  <c:v>140.2576028328995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3E59-46D7-A352-5C3B61C2D9AD}"/>
            </c:ext>
          </c:extLst>
        </c:ser>
        <c:ser>
          <c:idx val="3"/>
          <c:order val="3"/>
          <c:tx>
            <c:strRef>
              <c:f>DPPH!$DD$59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7:$DA$77</c:f>
                <c:numCache>
                  <c:formatCode>General</c:formatCode>
                  <c:ptCount val="5"/>
                  <c:pt idx="0">
                    <c:v>4.3983355166258873</c:v>
                  </c:pt>
                  <c:pt idx="1">
                    <c:v>8.0457357011468403E-2</c:v>
                  </c:pt>
                  <c:pt idx="2">
                    <c:v>2.2528059963206024</c:v>
                  </c:pt>
                  <c:pt idx="3">
                    <c:v>0.40228678505726162</c:v>
                  </c:pt>
                  <c:pt idx="4">
                    <c:v>3.1646560424503329</c:v>
                  </c:pt>
                </c:numCache>
              </c:numRef>
            </c:plus>
            <c:minus>
              <c:numRef>
                <c:f>DPPH!$CW$77:$DA$77</c:f>
                <c:numCache>
                  <c:formatCode>General</c:formatCode>
                  <c:ptCount val="5"/>
                  <c:pt idx="0">
                    <c:v>4.3983355166258873</c:v>
                  </c:pt>
                  <c:pt idx="1">
                    <c:v>8.0457357011468403E-2</c:v>
                  </c:pt>
                  <c:pt idx="2">
                    <c:v>2.2528059963206024</c:v>
                  </c:pt>
                  <c:pt idx="3">
                    <c:v>0.40228678505726162</c:v>
                  </c:pt>
                  <c:pt idx="4">
                    <c:v>3.16465604245033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E$55:$DI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E$59:$DI$59</c:f>
              <c:numCache>
                <c:formatCode>General</c:formatCode>
                <c:ptCount val="5"/>
                <c:pt idx="0">
                  <c:v>52.075091587228549</c:v>
                </c:pt>
                <c:pt idx="1">
                  <c:v>106.63446467406628</c:v>
                </c:pt>
                <c:pt idx="2">
                  <c:v>128.23443893402742</c:v>
                </c:pt>
                <c:pt idx="3">
                  <c:v>136.90097821129015</c:v>
                </c:pt>
                <c:pt idx="4">
                  <c:v>143.772939165077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3E59-46D7-A352-5C3B61C2D9AD}"/>
            </c:ext>
          </c:extLst>
        </c:ser>
        <c:ser>
          <c:idx val="4"/>
          <c:order val="4"/>
          <c:tx>
            <c:strRef>
              <c:f>DPPH!$DD$60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8:$DA$78</c:f>
                <c:numCache>
                  <c:formatCode>General</c:formatCode>
                  <c:ptCount val="5"/>
                  <c:pt idx="0">
                    <c:v>2.4941780673549072</c:v>
                  </c:pt>
                  <c:pt idx="1">
                    <c:v>0.93866916513357024</c:v>
                  </c:pt>
                  <c:pt idx="2">
                    <c:v>1.6091471402289861</c:v>
                  </c:pt>
                  <c:pt idx="3">
                    <c:v>0.34864854704958254</c:v>
                  </c:pt>
                  <c:pt idx="4">
                    <c:v>1.1264029981602763</c:v>
                  </c:pt>
                </c:numCache>
              </c:numRef>
            </c:plus>
            <c:minus>
              <c:numRef>
                <c:f>DPPH!$CW$78:$DA$78</c:f>
                <c:numCache>
                  <c:formatCode>General</c:formatCode>
                  <c:ptCount val="5"/>
                  <c:pt idx="0">
                    <c:v>2.4941780673549072</c:v>
                  </c:pt>
                  <c:pt idx="1">
                    <c:v>0.93866916513357024</c:v>
                  </c:pt>
                  <c:pt idx="2">
                    <c:v>1.6091471402289861</c:v>
                  </c:pt>
                  <c:pt idx="3">
                    <c:v>0.34864854704958254</c:v>
                  </c:pt>
                  <c:pt idx="4">
                    <c:v>1.12640299816027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E$55:$DI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E$60:$DI$60</c:f>
              <c:numCache>
                <c:formatCode>General</c:formatCode>
                <c:ptCount val="5"/>
                <c:pt idx="0">
                  <c:v>52.075091587228549</c:v>
                </c:pt>
                <c:pt idx="1">
                  <c:v>132.88061425772406</c:v>
                </c:pt>
                <c:pt idx="2">
                  <c:v>141.55453556646401</c:v>
                </c:pt>
                <c:pt idx="3">
                  <c:v>158.14063683390336</c:v>
                </c:pt>
                <c:pt idx="4">
                  <c:v>156.832122150903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3E59-46D7-A352-5C3B61C2D9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8476872"/>
        <c:axId val="418474912"/>
      </c:scatterChart>
      <c:valAx>
        <c:axId val="418476872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8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8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6019666443470294"/>
              <c:y val="0.919593823374709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474912"/>
        <c:crosses val="autoZero"/>
        <c:crossBetween val="midCat"/>
        <c:majorUnit val="5"/>
      </c:valAx>
      <c:valAx>
        <c:axId val="418474912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PPH</a:t>
                </a:r>
                <a:r>
                  <a:rPr lang="en-US" sz="800" b="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adical scavenging activity </a:t>
                </a:r>
                <a:endParaRPr lang="en-US" sz="800" b="0" baseline="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 sz="8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800" b="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800" b="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sz="800" b="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E/g placenta protein)</a:t>
                </a:r>
                <a:endParaRPr lang="en-US" sz="800" b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476872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4157925275596378"/>
          <c:y val="4.5991583604430175E-2"/>
          <c:w val="0.80252073789947653"/>
          <c:h val="6.62985178595118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28566330753143"/>
          <c:y val="2.8326176428484819E-2"/>
          <c:w val="0.77638832685798853"/>
          <c:h val="0.8140643014343141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DPPH!$DN$56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0:$DA$60</c:f>
                <c:numCache>
                  <c:formatCode>General</c:formatCode>
                  <c:ptCount val="5"/>
                  <c:pt idx="0">
                    <c:v>3.057379566435086</c:v>
                  </c:pt>
                  <c:pt idx="1">
                    <c:v>0.32182942804578818</c:v>
                  </c:pt>
                  <c:pt idx="2">
                    <c:v>3.4596663514923072</c:v>
                  </c:pt>
                  <c:pt idx="3">
                    <c:v>0.77775445111066355</c:v>
                  </c:pt>
                  <c:pt idx="4">
                    <c:v>0.67047797509541596</c:v>
                  </c:pt>
                </c:numCache>
              </c:numRef>
            </c:plus>
            <c:minus>
              <c:numRef>
                <c:f>DPPH!$CW$60:$DA$60</c:f>
                <c:numCache>
                  <c:formatCode>General</c:formatCode>
                  <c:ptCount val="5"/>
                  <c:pt idx="0">
                    <c:v>3.057379566435086</c:v>
                  </c:pt>
                  <c:pt idx="1">
                    <c:v>0.32182942804578818</c:v>
                  </c:pt>
                  <c:pt idx="2">
                    <c:v>3.4596663514923072</c:v>
                  </c:pt>
                  <c:pt idx="3">
                    <c:v>0.77775445111066355</c:v>
                  </c:pt>
                  <c:pt idx="4">
                    <c:v>0.670477975095415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O$55:$DS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O$56:$DS$56</c:f>
              <c:numCache>
                <c:formatCode>General</c:formatCode>
                <c:ptCount val="5"/>
                <c:pt idx="0">
                  <c:v>40.584493763463598</c:v>
                </c:pt>
                <c:pt idx="1">
                  <c:v>52.075091587228549</c:v>
                </c:pt>
                <c:pt idx="2">
                  <c:v>64.799922779883431</c:v>
                </c:pt>
                <c:pt idx="3">
                  <c:v>70.299477244667202</c:v>
                </c:pt>
                <c:pt idx="4">
                  <c:v>73.29578622892870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9BC3-4461-B0A8-8AC92001B0B3}"/>
            </c:ext>
          </c:extLst>
        </c:ser>
        <c:ser>
          <c:idx val="1"/>
          <c:order val="1"/>
          <c:tx>
            <c:strRef>
              <c:f>DPPH!$DN$57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1:$DA$61</c:f>
                <c:numCache>
                  <c:formatCode>General</c:formatCode>
                  <c:ptCount val="5"/>
                  <c:pt idx="0">
                    <c:v>5.3638238007648949E-2</c:v>
                  </c:pt>
                  <c:pt idx="1">
                    <c:v>0.26819119003817438</c:v>
                  </c:pt>
                  <c:pt idx="2">
                    <c:v>5.3638238007618806E-2</c:v>
                  </c:pt>
                  <c:pt idx="3">
                    <c:v>0.34864854704962267</c:v>
                  </c:pt>
                  <c:pt idx="4">
                    <c:v>0.50956326107248917</c:v>
                  </c:pt>
                </c:numCache>
              </c:numRef>
            </c:plus>
            <c:minus>
              <c:numRef>
                <c:f>DPPH!$CW$61:$DA$61</c:f>
                <c:numCache>
                  <c:formatCode>General</c:formatCode>
                  <c:ptCount val="5"/>
                  <c:pt idx="0">
                    <c:v>5.3638238007648949E-2</c:v>
                  </c:pt>
                  <c:pt idx="1">
                    <c:v>0.26819119003817438</c:v>
                  </c:pt>
                  <c:pt idx="2">
                    <c:v>5.3638238007618806E-2</c:v>
                  </c:pt>
                  <c:pt idx="3">
                    <c:v>0.34864854704962267</c:v>
                  </c:pt>
                  <c:pt idx="4">
                    <c:v>0.509563261072489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O$55:$DS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O$57:$DS$57</c:f>
              <c:numCache>
                <c:formatCode>General</c:formatCode>
                <c:ptCount val="5"/>
                <c:pt idx="0">
                  <c:v>40.584493763463598</c:v>
                </c:pt>
                <c:pt idx="1">
                  <c:v>100.62288272463019</c:v>
                </c:pt>
                <c:pt idx="2">
                  <c:v>106.08450922758792</c:v>
                </c:pt>
                <c:pt idx="3">
                  <c:v>108.49293480354493</c:v>
                </c:pt>
                <c:pt idx="4">
                  <c:v>122.4504247555479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9BC3-4461-B0A8-8AC92001B0B3}"/>
            </c:ext>
          </c:extLst>
        </c:ser>
        <c:ser>
          <c:idx val="2"/>
          <c:order val="2"/>
          <c:tx>
            <c:strRef>
              <c:f>DPPH!$DN$58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2:$DA$62</c:f>
                <c:numCache>
                  <c:formatCode>General</c:formatCode>
                  <c:ptCount val="5"/>
                  <c:pt idx="0">
                    <c:v>0.40228678505725157</c:v>
                  </c:pt>
                  <c:pt idx="1">
                    <c:v>1.9041574492709701</c:v>
                  </c:pt>
                  <c:pt idx="2">
                    <c:v>8.0457357011468403E-2</c:v>
                  </c:pt>
                  <c:pt idx="3">
                    <c:v>0.56320149908015815</c:v>
                  </c:pt>
                  <c:pt idx="4">
                    <c:v>0.59002061808396766</c:v>
                  </c:pt>
                </c:numCache>
              </c:numRef>
            </c:plus>
            <c:minus>
              <c:numRef>
                <c:f>DPPH!$CW$62:$DA$62</c:f>
                <c:numCache>
                  <c:formatCode>General</c:formatCode>
                  <c:ptCount val="5"/>
                  <c:pt idx="0">
                    <c:v>0.40228678505725157</c:v>
                  </c:pt>
                  <c:pt idx="1">
                    <c:v>1.9041574492709701</c:v>
                  </c:pt>
                  <c:pt idx="2">
                    <c:v>8.0457357011468403E-2</c:v>
                  </c:pt>
                  <c:pt idx="3">
                    <c:v>0.56320149908015815</c:v>
                  </c:pt>
                  <c:pt idx="4">
                    <c:v>0.590020618083967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O$55:$DS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O$58:$DS$58</c:f>
              <c:numCache>
                <c:formatCode>General</c:formatCode>
                <c:ptCount val="5"/>
                <c:pt idx="0">
                  <c:v>40.584493763463598</c:v>
                </c:pt>
                <c:pt idx="1">
                  <c:v>135.95277916563776</c:v>
                </c:pt>
                <c:pt idx="2">
                  <c:v>144.22107484372648</c:v>
                </c:pt>
                <c:pt idx="3">
                  <c:v>148.88621414833619</c:v>
                </c:pt>
                <c:pt idx="4">
                  <c:v>163.1281638140348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9BC3-4461-B0A8-8AC92001B0B3}"/>
            </c:ext>
          </c:extLst>
        </c:ser>
        <c:ser>
          <c:idx val="3"/>
          <c:order val="3"/>
          <c:tx>
            <c:strRef>
              <c:f>DPPH!$DN$59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3:$DA$63</c:f>
                <c:numCache>
                  <c:formatCode>General</c:formatCode>
                  <c:ptCount val="5"/>
                  <c:pt idx="0">
                    <c:v>1.1264029981602863</c:v>
                  </c:pt>
                  <c:pt idx="1">
                    <c:v>0.72411621310301466</c:v>
                  </c:pt>
                  <c:pt idx="2">
                    <c:v>0.53638238007632877</c:v>
                  </c:pt>
                  <c:pt idx="3">
                    <c:v>2.8964648524121386</c:v>
                  </c:pt>
                  <c:pt idx="4">
                    <c:v>0.34864854704958254</c:v>
                  </c:pt>
                </c:numCache>
              </c:numRef>
            </c:plus>
            <c:minus>
              <c:numRef>
                <c:f>DPPH!$CW$63:$DA$63</c:f>
                <c:numCache>
                  <c:formatCode>General</c:formatCode>
                  <c:ptCount val="5"/>
                  <c:pt idx="0">
                    <c:v>1.1264029981602863</c:v>
                  </c:pt>
                  <c:pt idx="1">
                    <c:v>0.72411621310301466</c:v>
                  </c:pt>
                  <c:pt idx="2">
                    <c:v>0.53638238007632877</c:v>
                  </c:pt>
                  <c:pt idx="3">
                    <c:v>2.8964648524121386</c:v>
                  </c:pt>
                  <c:pt idx="4">
                    <c:v>0.348648547049582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O$55:$DS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O$59:$DS$59</c:f>
              <c:numCache>
                <c:formatCode>General</c:formatCode>
                <c:ptCount val="5"/>
                <c:pt idx="0">
                  <c:v>40.584493763463598</c:v>
                </c:pt>
                <c:pt idx="1">
                  <c:v>150.74468427781486</c:v>
                </c:pt>
                <c:pt idx="2">
                  <c:v>159.13923686125</c:v>
                </c:pt>
                <c:pt idx="3">
                  <c:v>165.22069267551501</c:v>
                </c:pt>
                <c:pt idx="4">
                  <c:v>167.0537078630357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9BC3-4461-B0A8-8AC92001B0B3}"/>
            </c:ext>
          </c:extLst>
        </c:ser>
        <c:ser>
          <c:idx val="4"/>
          <c:order val="4"/>
          <c:tx>
            <c:strRef>
              <c:f>DPPH!$DN$60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4:$DA$64</c:f>
                <c:numCache>
                  <c:formatCode>General</c:formatCode>
                  <c:ptCount val="5"/>
                  <c:pt idx="0">
                    <c:v>0.42910590406107102</c:v>
                  </c:pt>
                  <c:pt idx="1">
                    <c:v>0.53638238007632877</c:v>
                  </c:pt>
                  <c:pt idx="2">
                    <c:v>7.7507253921029067</c:v>
                  </c:pt>
                  <c:pt idx="3">
                    <c:v>0.85821180812212194</c:v>
                  </c:pt>
                  <c:pt idx="4">
                    <c:v>0.10727647601525771</c:v>
                  </c:pt>
                </c:numCache>
              </c:numRef>
            </c:plus>
            <c:minus>
              <c:numRef>
                <c:f>DPPH!$CW$64:$DA$64</c:f>
                <c:numCache>
                  <c:formatCode>General</c:formatCode>
                  <c:ptCount val="5"/>
                  <c:pt idx="0">
                    <c:v>0.42910590406107102</c:v>
                  </c:pt>
                  <c:pt idx="1">
                    <c:v>0.53638238007632877</c:v>
                  </c:pt>
                  <c:pt idx="2">
                    <c:v>7.7507253921029067</c:v>
                  </c:pt>
                  <c:pt idx="3">
                    <c:v>0.85821180812212194</c:v>
                  </c:pt>
                  <c:pt idx="4">
                    <c:v>0.107276476015257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DO$55:$DS$5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DO$60:$DS$60</c:f>
              <c:numCache>
                <c:formatCode>General</c:formatCode>
                <c:ptCount val="5"/>
                <c:pt idx="0">
                  <c:v>40.584493763463598</c:v>
                </c:pt>
                <c:pt idx="1">
                  <c:v>160.82754006473201</c:v>
                </c:pt>
                <c:pt idx="2">
                  <c:v>169.468115497817</c:v>
                </c:pt>
                <c:pt idx="3">
                  <c:v>176.17538268221156</c:v>
                </c:pt>
                <c:pt idx="4">
                  <c:v>179.6647551702123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9BC3-4461-B0A8-8AC92001B0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8477264"/>
        <c:axId val="418480008"/>
      </c:scatterChart>
      <c:valAx>
        <c:axId val="418477264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8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8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689350145724615"/>
              <c:y val="0.904193044615856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480008"/>
        <c:crosses val="autoZero"/>
        <c:crossBetween val="midCat"/>
        <c:majorUnit val="5"/>
      </c:valAx>
      <c:valAx>
        <c:axId val="41848000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PPH</a:t>
                </a:r>
                <a:r>
                  <a:rPr lang="en-US" sz="80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adical scavenging activity </a:t>
                </a:r>
                <a:endParaRPr lang="en-US" sz="800" baseline="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800" baseline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800" baseline="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sz="80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E/g placenta protein)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0913782402381761E-2"/>
              <c:y val="5.774770014704071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477264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7989271946331295"/>
          <c:y val="4.214402649944448E-2"/>
          <c:w val="0.77956509413471287"/>
          <c:h val="7.196890046727293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138094894883681"/>
          <c:y val="5.5391815650644785E-2"/>
          <c:w val="0.76970761418179623"/>
          <c:h val="0.7960049068867054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DPPH!$CM$57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53:$DA$53</c:f>
                <c:numCache>
                  <c:formatCode>General</c:formatCode>
                  <c:ptCount val="5"/>
                  <c:pt idx="0">
                    <c:v>4.9564306554477096</c:v>
                  </c:pt>
                  <c:pt idx="1">
                    <c:v>8.9535521517764796</c:v>
                  </c:pt>
                  <c:pt idx="2">
                    <c:v>2.6723612289740708</c:v>
                  </c:pt>
                  <c:pt idx="3">
                    <c:v>4.95643065544769</c:v>
                  </c:pt>
                  <c:pt idx="4">
                    <c:v>0.93646846485400004</c:v>
                  </c:pt>
                </c:numCache>
              </c:numRef>
            </c:plus>
            <c:minus>
              <c:numRef>
                <c:f>DPPH!$CW$53:$DA$53</c:f>
                <c:numCache>
                  <c:formatCode>General</c:formatCode>
                  <c:ptCount val="5"/>
                  <c:pt idx="0">
                    <c:v>4.9564306554477096</c:v>
                  </c:pt>
                  <c:pt idx="1">
                    <c:v>8.9535521517764796</c:v>
                  </c:pt>
                  <c:pt idx="2">
                    <c:v>2.6723612289740708</c:v>
                  </c:pt>
                  <c:pt idx="3">
                    <c:v>4.95643065544769</c:v>
                  </c:pt>
                  <c:pt idx="4">
                    <c:v>0.93646846485400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CN$56:$CR$56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CN$57:$CR$57</c:f>
              <c:numCache>
                <c:formatCode>General</c:formatCode>
                <c:ptCount val="5"/>
                <c:pt idx="0">
                  <c:v>47.764285861142803</c:v>
                </c:pt>
                <c:pt idx="1">
                  <c:v>52.075091587228549</c:v>
                </c:pt>
                <c:pt idx="2">
                  <c:v>64.799922779883431</c:v>
                </c:pt>
                <c:pt idx="3">
                  <c:v>70.299477244667202</c:v>
                </c:pt>
                <c:pt idx="4">
                  <c:v>73.29578622892870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2595-4228-B8EF-660AF57E24DC}"/>
            </c:ext>
          </c:extLst>
        </c:ser>
        <c:ser>
          <c:idx val="1"/>
          <c:order val="1"/>
          <c:tx>
            <c:strRef>
              <c:f>DPPH!$CM$58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54:$DA$54</c:f>
                <c:numCache>
                  <c:formatCode>General</c:formatCode>
                  <c:ptCount val="5"/>
                  <c:pt idx="0">
                    <c:v>3.311900668386758</c:v>
                  </c:pt>
                  <c:pt idx="1">
                    <c:v>1.1032055329867401</c:v>
                  </c:pt>
                  <c:pt idx="2">
                    <c:v>4.0656435791230097</c:v>
                  </c:pt>
                  <c:pt idx="3">
                    <c:v>0.43397319102996856</c:v>
                  </c:pt>
                  <c:pt idx="4">
                    <c:v>0.36545110823574928</c:v>
                  </c:pt>
                </c:numCache>
              </c:numRef>
            </c:plus>
            <c:minus>
              <c:numRef>
                <c:f>DPPH!$CW$54:$DA$54</c:f>
                <c:numCache>
                  <c:formatCode>General</c:formatCode>
                  <c:ptCount val="5"/>
                  <c:pt idx="0">
                    <c:v>3.311900668386758</c:v>
                  </c:pt>
                  <c:pt idx="1">
                    <c:v>1.1032055329867401</c:v>
                  </c:pt>
                  <c:pt idx="2">
                    <c:v>4.0656435791230097</c:v>
                  </c:pt>
                  <c:pt idx="3">
                    <c:v>0.43397319102996856</c:v>
                  </c:pt>
                  <c:pt idx="4">
                    <c:v>0.365451108235749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CN$56:$CR$56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CN$58:$CR$58</c:f>
              <c:numCache>
                <c:formatCode>General</c:formatCode>
                <c:ptCount val="5"/>
                <c:pt idx="0">
                  <c:v>52.075091587228549</c:v>
                </c:pt>
                <c:pt idx="1">
                  <c:v>211.48955688638199</c:v>
                </c:pt>
                <c:pt idx="2">
                  <c:v>216.32394648267663</c:v>
                </c:pt>
                <c:pt idx="3">
                  <c:v>216.92152644533601</c:v>
                </c:pt>
                <c:pt idx="4">
                  <c:v>223.3333979365725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2595-4228-B8EF-660AF57E24DC}"/>
            </c:ext>
          </c:extLst>
        </c:ser>
        <c:ser>
          <c:idx val="2"/>
          <c:order val="2"/>
          <c:tx>
            <c:strRef>
              <c:f>DPPH!$CM$59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55:$DA$55</c:f>
                <c:numCache>
                  <c:formatCode>General</c:formatCode>
                  <c:ptCount val="5"/>
                  <c:pt idx="0">
                    <c:v>0.2512476369120839</c:v>
                  </c:pt>
                  <c:pt idx="1">
                    <c:v>0.27408833117681697</c:v>
                  </c:pt>
                  <c:pt idx="2">
                    <c:v>0.29692902544155003</c:v>
                  </c:pt>
                  <c:pt idx="3">
                    <c:v>1.12147808839854</c:v>
                  </c:pt>
                  <c:pt idx="4">
                    <c:v>0.27408833117683706</c:v>
                  </c:pt>
                </c:numCache>
              </c:numRef>
            </c:plus>
            <c:minus>
              <c:numRef>
                <c:f>DPPH!$CW$55:$DA$55</c:f>
                <c:numCache>
                  <c:formatCode>General</c:formatCode>
                  <c:ptCount val="5"/>
                  <c:pt idx="0">
                    <c:v>0.2512476369120839</c:v>
                  </c:pt>
                  <c:pt idx="1">
                    <c:v>0.27408833117681697</c:v>
                  </c:pt>
                  <c:pt idx="2">
                    <c:v>0.29692902544155003</c:v>
                  </c:pt>
                  <c:pt idx="3">
                    <c:v>1.12147808839854</c:v>
                  </c:pt>
                  <c:pt idx="4">
                    <c:v>0.274088331176837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CN$56:$CR$56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CN$59:$CR$59</c:f>
              <c:numCache>
                <c:formatCode>General</c:formatCode>
                <c:ptCount val="5"/>
                <c:pt idx="0">
                  <c:v>64.799922779883431</c:v>
                </c:pt>
                <c:pt idx="1">
                  <c:v>233.08848705674103</c:v>
                </c:pt>
                <c:pt idx="2">
                  <c:v>244.24869662964903</c:v>
                </c:pt>
                <c:pt idx="3">
                  <c:v>246.21909542544469</c:v>
                </c:pt>
                <c:pt idx="4">
                  <c:v>251.5327118501722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2595-4228-B8EF-660AF57E24DC}"/>
            </c:ext>
          </c:extLst>
        </c:ser>
        <c:ser>
          <c:idx val="3"/>
          <c:order val="3"/>
          <c:tx>
            <c:strRef>
              <c:f>DPPH!$CM$60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56:$DA$5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9942429926575809</c:v>
                  </c:pt>
                  <c:pt idx="2">
                    <c:v>7.902880215598648</c:v>
                  </c:pt>
                  <c:pt idx="3">
                    <c:v>1.8044148469141741</c:v>
                  </c:pt>
                  <c:pt idx="4">
                    <c:v>3.9514401077992436</c:v>
                  </c:pt>
                </c:numCache>
              </c:numRef>
            </c:plus>
            <c:minus>
              <c:numRef>
                <c:f>DPPH!$CW$56:$DA$5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79942429926575809</c:v>
                  </c:pt>
                  <c:pt idx="2">
                    <c:v>7.902880215598648</c:v>
                  </c:pt>
                  <c:pt idx="3">
                    <c:v>1.8044148469141741</c:v>
                  </c:pt>
                  <c:pt idx="4">
                    <c:v>3.95144010779924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CN$56:$CR$56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CN$60:$CR$60</c:f>
              <c:numCache>
                <c:formatCode>General</c:formatCode>
                <c:ptCount val="5"/>
                <c:pt idx="0">
                  <c:v>70.299477244667202</c:v>
                </c:pt>
                <c:pt idx="1">
                  <c:v>258.42910763545689</c:v>
                </c:pt>
                <c:pt idx="2">
                  <c:v>260.90018153510215</c:v>
                </c:pt>
                <c:pt idx="3">
                  <c:v>268.9271340064991</c:v>
                </c:pt>
                <c:pt idx="4">
                  <c:v>264.0495894464148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2595-4228-B8EF-660AF57E24DC}"/>
            </c:ext>
          </c:extLst>
        </c:ser>
        <c:ser>
          <c:idx val="4"/>
          <c:order val="4"/>
          <c:tx>
            <c:strRef>
              <c:f>DPPH!$CM$61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57:$DA$57</c:f>
                <c:numCache>
                  <c:formatCode>General</c:formatCode>
                  <c:ptCount val="5"/>
                  <c:pt idx="0">
                    <c:v>0.13704416558839844</c:v>
                  </c:pt>
                  <c:pt idx="1">
                    <c:v>0.31976971970634344</c:v>
                  </c:pt>
                  <c:pt idx="2">
                    <c:v>9.1362777058892106E-2</c:v>
                  </c:pt>
                  <c:pt idx="3">
                    <c:v>0.22840694264733075</c:v>
                  </c:pt>
                  <c:pt idx="4">
                    <c:v>0.38829180250048234</c:v>
                  </c:pt>
                </c:numCache>
              </c:numRef>
            </c:plus>
            <c:minus>
              <c:numRef>
                <c:f>DPPH!$CW$57:$DA$57</c:f>
                <c:numCache>
                  <c:formatCode>General</c:formatCode>
                  <c:ptCount val="5"/>
                  <c:pt idx="0">
                    <c:v>0.13704416558839844</c:v>
                  </c:pt>
                  <c:pt idx="1">
                    <c:v>0.31976971970634344</c:v>
                  </c:pt>
                  <c:pt idx="2">
                    <c:v>9.1362777058892106E-2</c:v>
                  </c:pt>
                  <c:pt idx="3">
                    <c:v>0.22840694264733075</c:v>
                  </c:pt>
                  <c:pt idx="4">
                    <c:v>0.388291802500482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DPPH!$CN$56:$CR$56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DPPH!$CN$61:$CR$61</c:f>
              <c:numCache>
                <c:formatCode>General</c:formatCode>
                <c:ptCount val="5"/>
                <c:pt idx="0">
                  <c:v>73.295786228928705</c:v>
                </c:pt>
                <c:pt idx="1">
                  <c:v>275.92043465059339</c:v>
                </c:pt>
                <c:pt idx="2">
                  <c:v>277.85853182678585</c:v>
                </c:pt>
                <c:pt idx="3">
                  <c:v>279.47361280694616</c:v>
                </c:pt>
                <c:pt idx="4">
                  <c:v>284.6580227532608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2595-4228-B8EF-660AF57E24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8478832"/>
        <c:axId val="418477656"/>
      </c:scatterChart>
      <c:valAx>
        <c:axId val="418478832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8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8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689350145724615"/>
              <c:y val="0.904193044615856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477656"/>
        <c:crosses val="autoZero"/>
        <c:crossBetween val="midCat"/>
        <c:majorUnit val="5"/>
      </c:valAx>
      <c:valAx>
        <c:axId val="41847765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PPH</a:t>
                </a:r>
                <a:r>
                  <a:rPr lang="en-US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adical scavenging activity </a:t>
                </a:r>
                <a:endParaRPr lang="en-US" sz="800" baseline="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 sz="8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8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8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E/g placenta protein)</a:t>
                </a:r>
                <a:endPara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478832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8917492371029176"/>
          <c:y val="6.4391831099992608E-2"/>
          <c:w val="0.75652874126666925"/>
          <c:h val="6.510240958368453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015522405397042"/>
          <c:y val="2.8326176428484819E-2"/>
          <c:w val="0.75350030599929019"/>
          <c:h val="0.8140643014343141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R$95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68:$O$68</c:f>
                <c:numCache>
                  <c:formatCode>General</c:formatCode>
                  <c:ptCount val="5"/>
                  <c:pt idx="0">
                    <c:v>1.3685710341003562E-2</c:v>
                  </c:pt>
                  <c:pt idx="1">
                    <c:v>0.22972442358112763</c:v>
                  </c:pt>
                  <c:pt idx="2">
                    <c:v>0.75271406875518343</c:v>
                  </c:pt>
                  <c:pt idx="3">
                    <c:v>7.5760182244838187E-2</c:v>
                  </c:pt>
                  <c:pt idx="4">
                    <c:v>0.54742841364013251</c:v>
                  </c:pt>
                </c:numCache>
              </c:numRef>
            </c:plus>
            <c:minus>
              <c:numRef>
                <c:f>Sheet1!$K$68:$O$68</c:f>
                <c:numCache>
                  <c:formatCode>General</c:formatCode>
                  <c:ptCount val="5"/>
                  <c:pt idx="0">
                    <c:v>1.3685710341003562E-2</c:v>
                  </c:pt>
                  <c:pt idx="1">
                    <c:v>0.22972442358112763</c:v>
                  </c:pt>
                  <c:pt idx="2">
                    <c:v>0.75271406875518343</c:v>
                  </c:pt>
                  <c:pt idx="3">
                    <c:v>7.5760182244838187E-2</c:v>
                  </c:pt>
                  <c:pt idx="4">
                    <c:v>0.547428413640132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94:$W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95:$W$95</c:f>
              <c:numCache>
                <c:formatCode>0.00%</c:formatCode>
                <c:ptCount val="5"/>
                <c:pt idx="0" formatCode="General">
                  <c:v>88.731325328895082</c:v>
                </c:pt>
                <c:pt idx="1">
                  <c:v>567.58087102537615</c:v>
                </c:pt>
                <c:pt idx="2" formatCode="General">
                  <c:v>576.27330043951156</c:v>
                </c:pt>
                <c:pt idx="3" formatCode="General">
                  <c:v>584.42309305622598</c:v>
                </c:pt>
                <c:pt idx="4" formatCode="General">
                  <c:v>586.912834042413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807B-4E88-BD7F-A97D8CED3341}"/>
            </c:ext>
          </c:extLst>
        </c:ser>
        <c:ser>
          <c:idx val="1"/>
          <c:order val="1"/>
          <c:tx>
            <c:strRef>
              <c:f>Sheet1!$R$96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69:$O$69</c:f>
                <c:numCache>
                  <c:formatCode>General</c:formatCode>
                  <c:ptCount val="5"/>
                  <c:pt idx="0">
                    <c:v>0.27371420682006598</c:v>
                  </c:pt>
                  <c:pt idx="1">
                    <c:v>1.8084688664897295</c:v>
                  </c:pt>
                  <c:pt idx="2">
                    <c:v>8.7979566477879689E-2</c:v>
                  </c:pt>
                  <c:pt idx="3">
                    <c:v>0.46922435454868494</c:v>
                  </c:pt>
                  <c:pt idx="4">
                    <c:v>0.70383653182302741</c:v>
                  </c:pt>
                </c:numCache>
              </c:numRef>
            </c:plus>
            <c:minus>
              <c:numRef>
                <c:f>Sheet1!$K$69:$O$69</c:f>
                <c:numCache>
                  <c:formatCode>General</c:formatCode>
                  <c:ptCount val="5"/>
                  <c:pt idx="0">
                    <c:v>0.27371420682006598</c:v>
                  </c:pt>
                  <c:pt idx="1">
                    <c:v>1.8084688664897295</c:v>
                  </c:pt>
                  <c:pt idx="2">
                    <c:v>8.7979566477879689E-2</c:v>
                  </c:pt>
                  <c:pt idx="3">
                    <c:v>0.46922435454868494</c:v>
                  </c:pt>
                  <c:pt idx="4">
                    <c:v>0.703836531823027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94:$W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96:$W$96</c:f>
              <c:numCache>
                <c:formatCode>0.00%</c:formatCode>
                <c:ptCount val="5"/>
                <c:pt idx="0" formatCode="General">
                  <c:v>281.00946746540166</c:v>
                </c:pt>
                <c:pt idx="1">
                  <c:v>1342.5283381543634</c:v>
                </c:pt>
                <c:pt idx="2" formatCode="General">
                  <c:v>1360.6085913357647</c:v>
                </c:pt>
                <c:pt idx="3" formatCode="General">
                  <c:v>1364.7809574545495</c:v>
                </c:pt>
                <c:pt idx="4" formatCode="General">
                  <c:v>1384.947393695343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807B-4E88-BD7F-A97D8CED3341}"/>
            </c:ext>
          </c:extLst>
        </c:ser>
        <c:ser>
          <c:idx val="2"/>
          <c:order val="2"/>
          <c:tx>
            <c:strRef>
              <c:f>Sheet1!$R$97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70:$O$70</c:f>
                <c:numCache>
                  <c:formatCode>General</c:formatCode>
                  <c:ptCount val="5"/>
                  <c:pt idx="0">
                    <c:v>0.37146928068437807</c:v>
                  </c:pt>
                  <c:pt idx="1">
                    <c:v>0.29326522159292556</c:v>
                  </c:pt>
                  <c:pt idx="2">
                    <c:v>0.37146928068437807</c:v>
                  </c:pt>
                  <c:pt idx="3">
                    <c:v>0.64518348750443433</c:v>
                  </c:pt>
                  <c:pt idx="4">
                    <c:v>0.91889769432449542</c:v>
                  </c:pt>
                </c:numCache>
              </c:numRef>
            </c:plus>
            <c:minus>
              <c:numRef>
                <c:f>Sheet1!$K$70:$O$70</c:f>
                <c:numCache>
                  <c:formatCode>General</c:formatCode>
                  <c:ptCount val="5"/>
                  <c:pt idx="0">
                    <c:v>0.37146928068437807</c:v>
                  </c:pt>
                  <c:pt idx="1">
                    <c:v>0.29326522159292556</c:v>
                  </c:pt>
                  <c:pt idx="2">
                    <c:v>0.37146928068437807</c:v>
                  </c:pt>
                  <c:pt idx="3">
                    <c:v>0.64518348750443433</c:v>
                  </c:pt>
                  <c:pt idx="4">
                    <c:v>0.918897694324495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94:$W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97:$W$97</c:f>
              <c:numCache>
                <c:formatCode>0.00%</c:formatCode>
                <c:ptCount val="5"/>
                <c:pt idx="0" formatCode="General">
                  <c:v>282.08522067604162</c:v>
                </c:pt>
                <c:pt idx="1">
                  <c:v>1768.8746160588694</c:v>
                </c:pt>
                <c:pt idx="2" formatCode="General">
                  <c:v>1804.9655829863593</c:v>
                </c:pt>
                <c:pt idx="3" formatCode="General">
                  <c:v>2169.839000074101</c:v>
                </c:pt>
                <c:pt idx="4" formatCode="General">
                  <c:v>2315.037341007816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807B-4E88-BD7F-A97D8CED3341}"/>
            </c:ext>
          </c:extLst>
        </c:ser>
        <c:ser>
          <c:idx val="3"/>
          <c:order val="3"/>
          <c:tx>
            <c:strRef>
              <c:f>Sheet1!$R$98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7:$DA$77</c:f>
                <c:numCache>
                  <c:formatCode>General</c:formatCode>
                  <c:ptCount val="5"/>
                  <c:pt idx="0">
                    <c:v>4.3983355166258873</c:v>
                  </c:pt>
                  <c:pt idx="1">
                    <c:v>8.0457357011468403E-2</c:v>
                  </c:pt>
                  <c:pt idx="2">
                    <c:v>2.2528059963206024</c:v>
                  </c:pt>
                  <c:pt idx="3">
                    <c:v>0.40228678505726162</c:v>
                  </c:pt>
                  <c:pt idx="4">
                    <c:v>3.1646560424503329</c:v>
                  </c:pt>
                </c:numCache>
              </c:numRef>
            </c:plus>
            <c:minus>
              <c:numRef>
                <c:f>DPPH!$CW$77:$DA$77</c:f>
                <c:numCache>
                  <c:formatCode>General</c:formatCode>
                  <c:ptCount val="5"/>
                  <c:pt idx="0">
                    <c:v>4.3983355166258873</c:v>
                  </c:pt>
                  <c:pt idx="1">
                    <c:v>8.0457357011468403E-2</c:v>
                  </c:pt>
                  <c:pt idx="2">
                    <c:v>2.2528059963206024</c:v>
                  </c:pt>
                  <c:pt idx="3">
                    <c:v>0.40228678505726162</c:v>
                  </c:pt>
                  <c:pt idx="4">
                    <c:v>3.16465604245033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94:$W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98:$W$98</c:f>
              <c:numCache>
                <c:formatCode>0.00%</c:formatCode>
                <c:ptCount val="5"/>
                <c:pt idx="0" formatCode="General">
                  <c:v>288.97818167372145</c:v>
                </c:pt>
                <c:pt idx="1">
                  <c:v>2240.8387635287581</c:v>
                </c:pt>
                <c:pt idx="2" formatCode="General">
                  <c:v>2297.8611004854852</c:v>
                </c:pt>
                <c:pt idx="3" formatCode="General">
                  <c:v>2544.5870169763011</c:v>
                </c:pt>
                <c:pt idx="4" formatCode="General">
                  <c:v>2902.85418770929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807B-4E88-BD7F-A97D8CED3341}"/>
            </c:ext>
          </c:extLst>
        </c:ser>
        <c:ser>
          <c:idx val="4"/>
          <c:order val="4"/>
          <c:tx>
            <c:strRef>
              <c:f>Sheet1!$R$99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8:$DA$78</c:f>
                <c:numCache>
                  <c:formatCode>General</c:formatCode>
                  <c:ptCount val="5"/>
                  <c:pt idx="0">
                    <c:v>2.4941780673549072</c:v>
                  </c:pt>
                  <c:pt idx="1">
                    <c:v>0.93866916513357024</c:v>
                  </c:pt>
                  <c:pt idx="2">
                    <c:v>1.6091471402289861</c:v>
                  </c:pt>
                  <c:pt idx="3">
                    <c:v>0.34864854704958254</c:v>
                  </c:pt>
                  <c:pt idx="4">
                    <c:v>1.1264029981602763</c:v>
                  </c:pt>
                </c:numCache>
              </c:numRef>
            </c:plus>
            <c:minus>
              <c:numRef>
                <c:f>DPPH!$CW$78:$DA$78</c:f>
                <c:numCache>
                  <c:formatCode>General</c:formatCode>
                  <c:ptCount val="5"/>
                  <c:pt idx="0">
                    <c:v>2.4941780673549072</c:v>
                  </c:pt>
                  <c:pt idx="1">
                    <c:v>0.93866916513357024</c:v>
                  </c:pt>
                  <c:pt idx="2">
                    <c:v>1.6091471402289861</c:v>
                  </c:pt>
                  <c:pt idx="3">
                    <c:v>0.34864854704958254</c:v>
                  </c:pt>
                  <c:pt idx="4">
                    <c:v>1.12640299816027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94:$W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99:$W$99</c:f>
              <c:numCache>
                <c:formatCode>General</c:formatCode>
                <c:ptCount val="5"/>
                <c:pt idx="0">
                  <c:v>291.55646479499097</c:v>
                </c:pt>
                <c:pt idx="1">
                  <c:v>2438.7709215183545</c:v>
                </c:pt>
                <c:pt idx="2">
                  <c:v>2606.5825698123417</c:v>
                </c:pt>
                <c:pt idx="3">
                  <c:v>2849.0153813845973</c:v>
                </c:pt>
                <c:pt idx="4">
                  <c:v>3004.791358182089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807B-4E88-BD7F-A97D8CED33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8475304"/>
        <c:axId val="418474520"/>
      </c:scatterChart>
      <c:valAx>
        <c:axId val="418475304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8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8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689350145724615"/>
              <c:y val="0.904193044615856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474520"/>
        <c:crosses val="autoZero"/>
        <c:crossBetween val="midCat"/>
        <c:majorUnit val="5"/>
      </c:valAx>
      <c:valAx>
        <c:axId val="41847452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TS radical scavenging activity </a:t>
                </a:r>
                <a:endParaRPr lang="en-US" sz="800" baseline="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 sz="8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8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8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E/g placenta protein)</a:t>
                </a:r>
                <a:endPara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475304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7747314627487415"/>
          <c:y val="3.7220654590241563E-2"/>
          <c:w val="0.76302788211610473"/>
          <c:h val="6.416206679641424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569586252040902"/>
          <c:y val="5.0202984979499106E-2"/>
          <c:w val="0.75652636806187779"/>
          <c:h val="0.8063211933551931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AB$95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54:$O$54</c:f>
                <c:numCache>
                  <c:formatCode>General</c:formatCode>
                  <c:ptCount val="5"/>
                  <c:pt idx="0">
                    <c:v>5.376529062536952E-2</c:v>
                  </c:pt>
                  <c:pt idx="1">
                    <c:v>0.21017340880826577</c:v>
                  </c:pt>
                  <c:pt idx="2">
                    <c:v>1.4409097887599192</c:v>
                  </c:pt>
                  <c:pt idx="3">
                    <c:v>0.50343863040119263</c:v>
                  </c:pt>
                  <c:pt idx="4">
                    <c:v>0.28348971420649716</c:v>
                  </c:pt>
                </c:numCache>
              </c:numRef>
            </c:plus>
            <c:minus>
              <c:numRef>
                <c:f>Sheet1!$K$54:$O$54</c:f>
                <c:numCache>
                  <c:formatCode>General</c:formatCode>
                  <c:ptCount val="5"/>
                  <c:pt idx="0">
                    <c:v>5.376529062536952E-2</c:v>
                  </c:pt>
                  <c:pt idx="1">
                    <c:v>0.21017340880826577</c:v>
                  </c:pt>
                  <c:pt idx="2">
                    <c:v>1.4409097887599192</c:v>
                  </c:pt>
                  <c:pt idx="3">
                    <c:v>0.50343863040119263</c:v>
                  </c:pt>
                  <c:pt idx="4">
                    <c:v>0.283489714206497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94:$AG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95:$AG$95</c:f>
              <c:numCache>
                <c:formatCode>0.00%</c:formatCode>
                <c:ptCount val="5"/>
                <c:pt idx="0" formatCode="General">
                  <c:v>88.731325328895082</c:v>
                </c:pt>
                <c:pt idx="1">
                  <c:v>565.63376683660999</c:v>
                </c:pt>
                <c:pt idx="2" formatCode="General">
                  <c:v>571.19692166165657</c:v>
                </c:pt>
                <c:pt idx="3" formatCode="General">
                  <c:v>600.89026054034252</c:v>
                </c:pt>
                <c:pt idx="4" formatCode="General">
                  <c:v>596.0225000684267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D568-4D6B-A18F-818DCC6D2587}"/>
            </c:ext>
          </c:extLst>
        </c:ser>
        <c:ser>
          <c:idx val="1"/>
          <c:order val="1"/>
          <c:tx>
            <c:strRef>
              <c:f>Sheet1!$AB$96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1:$DA$61</c:f>
                <c:numCache>
                  <c:formatCode>General</c:formatCode>
                  <c:ptCount val="5"/>
                  <c:pt idx="0">
                    <c:v>5.3638238007648949E-2</c:v>
                  </c:pt>
                  <c:pt idx="1">
                    <c:v>0.26819119003817438</c:v>
                  </c:pt>
                  <c:pt idx="2">
                    <c:v>5.3638238007618806E-2</c:v>
                  </c:pt>
                  <c:pt idx="3">
                    <c:v>0.34864854704962267</c:v>
                  </c:pt>
                  <c:pt idx="4">
                    <c:v>0.50956326107248917</c:v>
                  </c:pt>
                </c:numCache>
              </c:numRef>
            </c:plus>
            <c:minus>
              <c:numRef>
                <c:f>DPPH!$CW$61:$DA$61</c:f>
                <c:numCache>
                  <c:formatCode>General</c:formatCode>
                  <c:ptCount val="5"/>
                  <c:pt idx="0">
                    <c:v>5.3638238007648949E-2</c:v>
                  </c:pt>
                  <c:pt idx="1">
                    <c:v>0.26819119003817438</c:v>
                  </c:pt>
                  <c:pt idx="2">
                    <c:v>5.3638238007618806E-2</c:v>
                  </c:pt>
                  <c:pt idx="3">
                    <c:v>0.34864854704962267</c:v>
                  </c:pt>
                  <c:pt idx="4">
                    <c:v>0.509563261072489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94:$AG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96:$AG$96</c:f>
              <c:numCache>
                <c:formatCode>0.00%</c:formatCode>
                <c:ptCount val="5"/>
                <c:pt idx="0" formatCode="General">
                  <c:v>281.00946746540166</c:v>
                </c:pt>
                <c:pt idx="1">
                  <c:v>694.83803764831623</c:v>
                </c:pt>
                <c:pt idx="2" formatCode="General">
                  <c:v>789.68982741536047</c:v>
                </c:pt>
                <c:pt idx="3" formatCode="General">
                  <c:v>820.56533669436897</c:v>
                </c:pt>
                <c:pt idx="4" formatCode="General">
                  <c:v>941.7030330097579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D568-4D6B-A18F-818DCC6D2587}"/>
            </c:ext>
          </c:extLst>
        </c:ser>
        <c:ser>
          <c:idx val="2"/>
          <c:order val="2"/>
          <c:tx>
            <c:strRef>
              <c:f>Sheet1!$AB$97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2:$DA$62</c:f>
                <c:numCache>
                  <c:formatCode>General</c:formatCode>
                  <c:ptCount val="5"/>
                  <c:pt idx="0">
                    <c:v>0.40228678505725157</c:v>
                  </c:pt>
                  <c:pt idx="1">
                    <c:v>1.9041574492709701</c:v>
                  </c:pt>
                  <c:pt idx="2">
                    <c:v>8.0457357011468403E-2</c:v>
                  </c:pt>
                  <c:pt idx="3">
                    <c:v>0.56320149908015815</c:v>
                  </c:pt>
                  <c:pt idx="4">
                    <c:v>0.59002061808396766</c:v>
                  </c:pt>
                </c:numCache>
              </c:numRef>
            </c:plus>
            <c:minus>
              <c:numRef>
                <c:f>DPPH!$CW$62:$DA$62</c:f>
                <c:numCache>
                  <c:formatCode>General</c:formatCode>
                  <c:ptCount val="5"/>
                  <c:pt idx="0">
                    <c:v>0.40228678505725157</c:v>
                  </c:pt>
                  <c:pt idx="1">
                    <c:v>1.9041574492709701</c:v>
                  </c:pt>
                  <c:pt idx="2">
                    <c:v>8.0457357011468403E-2</c:v>
                  </c:pt>
                  <c:pt idx="3">
                    <c:v>0.56320149908015815</c:v>
                  </c:pt>
                  <c:pt idx="4">
                    <c:v>0.590020618083967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94:$AG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97:$AG$97</c:f>
              <c:numCache>
                <c:formatCode>0.00%</c:formatCode>
                <c:ptCount val="5"/>
                <c:pt idx="0" formatCode="General">
                  <c:v>282.08522067604162</c:v>
                </c:pt>
                <c:pt idx="1">
                  <c:v>846.99032211334008</c:v>
                </c:pt>
                <c:pt idx="2" formatCode="General">
                  <c:v>964.37288892182278</c:v>
                </c:pt>
                <c:pt idx="3" formatCode="General">
                  <c:v>1069.2383573739505</c:v>
                </c:pt>
                <c:pt idx="4" formatCode="General">
                  <c:v>1109.293072114285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D568-4D6B-A18F-818DCC6D2587}"/>
            </c:ext>
          </c:extLst>
        </c:ser>
        <c:ser>
          <c:idx val="3"/>
          <c:order val="3"/>
          <c:tx>
            <c:strRef>
              <c:f>Sheet1!$AB$98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58:$O$58</c:f>
                <c:numCache>
                  <c:formatCode>General</c:formatCode>
                  <c:ptCount val="5"/>
                  <c:pt idx="0">
                    <c:v>0.18573464034216644</c:v>
                  </c:pt>
                  <c:pt idx="1">
                    <c:v>0.4398978323893934</c:v>
                  </c:pt>
                  <c:pt idx="2">
                    <c:v>0.33236725113865434</c:v>
                  </c:pt>
                  <c:pt idx="3">
                    <c:v>8.7979566477874666E-2</c:v>
                  </c:pt>
                  <c:pt idx="4">
                    <c:v>0.49855087670796649</c:v>
                  </c:pt>
                </c:numCache>
              </c:numRef>
            </c:plus>
            <c:minus>
              <c:numRef>
                <c:f>Sheet1!$K$58:$O$58</c:f>
                <c:numCache>
                  <c:formatCode>General</c:formatCode>
                  <c:ptCount val="5"/>
                  <c:pt idx="0">
                    <c:v>0.18573464034216644</c:v>
                  </c:pt>
                  <c:pt idx="1">
                    <c:v>0.4398978323893934</c:v>
                  </c:pt>
                  <c:pt idx="2">
                    <c:v>0.33236725113865434</c:v>
                  </c:pt>
                  <c:pt idx="3">
                    <c:v>8.7979566477874666E-2</c:v>
                  </c:pt>
                  <c:pt idx="4">
                    <c:v>0.498550876707966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94:$AG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98:$AG$98</c:f>
              <c:numCache>
                <c:formatCode>0.00%</c:formatCode>
                <c:ptCount val="5"/>
                <c:pt idx="0" formatCode="General">
                  <c:v>288.97818167372145</c:v>
                </c:pt>
                <c:pt idx="1">
                  <c:v>3902.2054125936024</c:v>
                </c:pt>
                <c:pt idx="2" formatCode="General">
                  <c:v>3944.624468134582</c:v>
                </c:pt>
                <c:pt idx="3" formatCode="General">
                  <c:v>3973.1356366129467</c:v>
                </c:pt>
                <c:pt idx="4" formatCode="General">
                  <c:v>4015.554692153926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D568-4D6B-A18F-818DCC6D2587}"/>
            </c:ext>
          </c:extLst>
        </c:ser>
        <c:ser>
          <c:idx val="4"/>
          <c:order val="4"/>
          <c:tx>
            <c:strRef>
              <c:f>Sheet1!$AB$99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AC$94:$AG$94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99:$AG$99</c:f>
              <c:numCache>
                <c:formatCode>General</c:formatCode>
                <c:ptCount val="5"/>
                <c:pt idx="0">
                  <c:v>291.55646479499097</c:v>
                </c:pt>
                <c:pt idx="1">
                  <c:v>5106.2807350396188</c:v>
                </c:pt>
                <c:pt idx="2">
                  <c:v>5261.3536757877928</c:v>
                </c:pt>
                <c:pt idx="3">
                  <c:v>5534.6436565682052</c:v>
                </c:pt>
                <c:pt idx="4">
                  <c:v>5641.73438695035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D568-4D6B-A18F-818DCC6D25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9633608"/>
        <c:axId val="419632432"/>
      </c:scatterChart>
      <c:valAx>
        <c:axId val="419633608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8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8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445406889901492"/>
              <c:y val="0.9176703277111476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632432"/>
        <c:crosses val="autoZero"/>
        <c:crossBetween val="midCat"/>
        <c:majorUnit val="5"/>
      </c:valAx>
      <c:valAx>
        <c:axId val="419632432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TS radical scavenging activity </a:t>
                </a:r>
                <a:endParaRPr lang="en-US" sz="800" baseline="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 sz="8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8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8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E/g placenta protein)</a:t>
                </a:r>
                <a:endPara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633608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7315509841365878"/>
          <c:y val="6.7166485285869756E-2"/>
          <c:w val="0.77738310362414442"/>
          <c:h val="3.924028065118801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087396008670045"/>
          <c:y val="4.0611316971250082E-2"/>
          <c:w val="0.77214903430594917"/>
          <c:h val="0.8185124258114725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A$96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7:$O$47</c:f>
                <c:numCache>
                  <c:formatCode>General</c:formatCode>
                  <c:ptCount val="5"/>
                  <c:pt idx="0">
                    <c:v>0.18084688664897172</c:v>
                  </c:pt>
                  <c:pt idx="1">
                    <c:v>9.7755073864310635E-2</c:v>
                  </c:pt>
                  <c:pt idx="2">
                    <c:v>0.105086704404131</c:v>
                  </c:pt>
                  <c:pt idx="3">
                    <c:v>6.1096921165196182E-2</c:v>
                  </c:pt>
                  <c:pt idx="4">
                    <c:v>0.16862750241593147</c:v>
                  </c:pt>
                </c:numCache>
              </c:numRef>
            </c:plus>
            <c:minus>
              <c:numRef>
                <c:f>Sheet1!$K$47:$O$47</c:f>
                <c:numCache>
                  <c:formatCode>General</c:formatCode>
                  <c:ptCount val="5"/>
                  <c:pt idx="0">
                    <c:v>0.18084688664897172</c:v>
                  </c:pt>
                  <c:pt idx="1">
                    <c:v>9.7755073864310635E-2</c:v>
                  </c:pt>
                  <c:pt idx="2">
                    <c:v>0.105086704404131</c:v>
                  </c:pt>
                  <c:pt idx="3">
                    <c:v>6.1096921165196182E-2</c:v>
                  </c:pt>
                  <c:pt idx="4">
                    <c:v>0.168627502415931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5:$F$9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96:$F$96</c:f>
              <c:numCache>
                <c:formatCode>General</c:formatCode>
                <c:ptCount val="5"/>
                <c:pt idx="0">
                  <c:v>18.7313253288951</c:v>
                </c:pt>
                <c:pt idx="1">
                  <c:v>89.560102736975196</c:v>
                </c:pt>
                <c:pt idx="2">
                  <c:v>93.903278717828826</c:v>
                </c:pt>
                <c:pt idx="3">
                  <c:v>99.021357592294535</c:v>
                </c:pt>
                <c:pt idx="4">
                  <c:v>106.8331621901632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DE04-45B1-B902-1DB060A458C0}"/>
            </c:ext>
          </c:extLst>
        </c:ser>
        <c:ser>
          <c:idx val="1"/>
          <c:order val="1"/>
          <c:tx>
            <c:strRef>
              <c:f>Sheet1!$A$97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95:$F$9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97:$F$97</c:f>
              <c:numCache>
                <c:formatCode>General</c:formatCode>
                <c:ptCount val="5"/>
                <c:pt idx="0">
                  <c:v>28.009467465402</c:v>
                </c:pt>
                <c:pt idx="1">
                  <c:v>268.289169883272</c:v>
                </c:pt>
                <c:pt idx="2">
                  <c:v>273.07735870624703</c:v>
                </c:pt>
                <c:pt idx="3">
                  <c:v>280.03972620497666</c:v>
                </c:pt>
                <c:pt idx="4">
                  <c:v>327.1260518500611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DE04-45B1-B902-1DB060A458C0}"/>
            </c:ext>
          </c:extLst>
        </c:ser>
        <c:ser>
          <c:idx val="2"/>
          <c:order val="2"/>
          <c:tx>
            <c:strRef>
              <c:f>Sheet1!$A$98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9:$O$49</c:f>
                <c:numCache>
                  <c:formatCode>General</c:formatCode>
                  <c:ptCount val="5"/>
                  <c:pt idx="0">
                    <c:v>1.2219384233038985E-2</c:v>
                  </c:pt>
                  <c:pt idx="1">
                    <c:v>0.21261728565487381</c:v>
                  </c:pt>
                  <c:pt idx="2">
                    <c:v>9.775507386430686E-2</c:v>
                  </c:pt>
                  <c:pt idx="3">
                    <c:v>6.1096921165194926E-2</c:v>
                  </c:pt>
                  <c:pt idx="4">
                    <c:v>0.54009678310031206</c:v>
                  </c:pt>
                </c:numCache>
              </c:numRef>
            </c:plus>
            <c:minus>
              <c:numRef>
                <c:f>Sheet1!$K$49:$O$49</c:f>
                <c:numCache>
                  <c:formatCode>General</c:formatCode>
                  <c:ptCount val="5"/>
                  <c:pt idx="0">
                    <c:v>1.2219384233038985E-2</c:v>
                  </c:pt>
                  <c:pt idx="1">
                    <c:v>0.21261728565487381</c:v>
                  </c:pt>
                  <c:pt idx="2">
                    <c:v>9.775507386430686E-2</c:v>
                  </c:pt>
                  <c:pt idx="3">
                    <c:v>6.1096921165194926E-2</c:v>
                  </c:pt>
                  <c:pt idx="4">
                    <c:v>0.540096783100312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5:$F$9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98:$F$98</c:f>
              <c:numCache>
                <c:formatCode>General</c:formatCode>
                <c:ptCount val="5"/>
                <c:pt idx="0">
                  <c:v>28.085220676041999</c:v>
                </c:pt>
                <c:pt idx="1">
                  <c:v>274.44530474910999</c:v>
                </c:pt>
                <c:pt idx="2">
                  <c:v>295.76590662563513</c:v>
                </c:pt>
                <c:pt idx="3">
                  <c:v>314.34006870335247</c:v>
                </c:pt>
                <c:pt idx="4">
                  <c:v>339.4914836414513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DE04-45B1-B902-1DB060A458C0}"/>
            </c:ext>
          </c:extLst>
        </c:ser>
        <c:ser>
          <c:idx val="3"/>
          <c:order val="3"/>
          <c:tx>
            <c:strRef>
              <c:f>Sheet1!$A$99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50:$O$50</c:f>
                <c:numCache>
                  <c:formatCode>General</c:formatCode>
                  <c:ptCount val="5"/>
                  <c:pt idx="0">
                    <c:v>3.1770399005905878E-2</c:v>
                  </c:pt>
                  <c:pt idx="1">
                    <c:v>0.10264282755753049</c:v>
                  </c:pt>
                  <c:pt idx="2">
                    <c:v>0.26882645312685516</c:v>
                  </c:pt>
                  <c:pt idx="3">
                    <c:v>8.0647935938054291E-2</c:v>
                  </c:pt>
                  <c:pt idx="4">
                    <c:v>0.13685710341003313</c:v>
                  </c:pt>
                </c:numCache>
              </c:numRef>
            </c:plus>
            <c:minus>
              <c:numRef>
                <c:f>Sheet1!$K$50:$O$50</c:f>
                <c:numCache>
                  <c:formatCode>General</c:formatCode>
                  <c:ptCount val="5"/>
                  <c:pt idx="0">
                    <c:v>3.1770399005905878E-2</c:v>
                  </c:pt>
                  <c:pt idx="1">
                    <c:v>0.10264282755753049</c:v>
                  </c:pt>
                  <c:pt idx="2">
                    <c:v>0.26882645312685516</c:v>
                  </c:pt>
                  <c:pt idx="3">
                    <c:v>8.0647935938054291E-2</c:v>
                  </c:pt>
                  <c:pt idx="4">
                    <c:v>0.136857103410033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95:$F$9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99:$F$99</c:f>
              <c:numCache>
                <c:formatCode>General</c:formatCode>
                <c:ptCount val="5"/>
                <c:pt idx="0">
                  <c:v>29.978181673721</c:v>
                </c:pt>
                <c:pt idx="1">
                  <c:v>284.97406063016899</c:v>
                </c:pt>
                <c:pt idx="2">
                  <c:v>293.1876235043656</c:v>
                </c:pt>
                <c:pt idx="3">
                  <c:v>303.545647055666</c:v>
                </c:pt>
                <c:pt idx="4">
                  <c:v>332.3354325293562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DE04-45B1-B902-1DB060A458C0}"/>
            </c:ext>
          </c:extLst>
        </c:ser>
        <c:ser>
          <c:idx val="4"/>
          <c:order val="4"/>
          <c:tx>
            <c:strRef>
              <c:f>Sheet1!$A$100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95:$F$95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100:$F$100</c:f>
              <c:numCache>
                <c:formatCode>General</c:formatCode>
                <c:ptCount val="5"/>
                <c:pt idx="0">
                  <c:v>29.556464794991001</c:v>
                </c:pt>
                <c:pt idx="1">
                  <c:v>301.29079902835559</c:v>
                </c:pt>
                <c:pt idx="2">
                  <c:v>313.18247219992531</c:v>
                </c:pt>
                <c:pt idx="3">
                  <c:v>317.33414470324601</c:v>
                </c:pt>
                <c:pt idx="4">
                  <c:v>347.1262482639339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6-DE04-45B1-B902-1DB060A458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9628904"/>
        <c:axId val="419634784"/>
      </c:scatterChart>
      <c:valAx>
        <c:axId val="419628904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8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8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689341481468563"/>
              <c:y val="0.91000844354819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634784"/>
        <c:crosses val="autoZero"/>
        <c:crossBetween val="midCat"/>
        <c:majorUnit val="5"/>
      </c:valAx>
      <c:valAx>
        <c:axId val="41963478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800" b="0" i="0" baseline="0" dirty="0">
                    <a:effectLst/>
                  </a:rPr>
                  <a:t>ABTS radical scavenging activity </a:t>
                </a:r>
                <a:endParaRPr lang="en-US" sz="800" b="0" i="0" baseline="0" dirty="0" smtClean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800" b="0" i="0" baseline="0" dirty="0" smtClean="0">
                    <a:effectLst/>
                  </a:rPr>
                  <a:t>(</a:t>
                </a:r>
                <a:r>
                  <a:rPr lang="en-US" sz="800" b="0" i="0" baseline="0" dirty="0" err="1">
                    <a:effectLst/>
                  </a:rPr>
                  <a:t>mmol</a:t>
                </a:r>
                <a:r>
                  <a:rPr lang="en-US" sz="800" b="0" i="0" baseline="0" dirty="0">
                    <a:effectLst/>
                  </a:rPr>
                  <a:t> TE/g placenta protein)</a:t>
                </a:r>
                <a:endParaRPr lang="en-GB" sz="800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4082110978502189E-3"/>
              <c:y val="8.513319754744033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8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628904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7935186014055798"/>
          <c:y val="4.2333048810620187E-2"/>
          <c:w val="0.77194901284128814"/>
          <c:h val="6.9258701341000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8A00E7-4D81-4B24-84C3-DCED635936A3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h-T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931CA3-B140-4DE2-AD28-FE729612142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8795052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5384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19978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09884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55732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81731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02754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947171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20632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48166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211300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10521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06193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2BDBCA96-73D2-408F-B322-EBB50ABEC3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4660072"/>
              </p:ext>
            </p:extLst>
          </p:nvPr>
        </p:nvGraphicFramePr>
        <p:xfrm>
          <a:off x="230588" y="393436"/>
          <a:ext cx="3148717" cy="2615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977E7554-A1D8-46D8-A897-8EB383AC41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2355454"/>
              </p:ext>
            </p:extLst>
          </p:nvPr>
        </p:nvGraphicFramePr>
        <p:xfrm>
          <a:off x="103368" y="2970375"/>
          <a:ext cx="3235256" cy="26156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54CA8456-06FC-4FF6-8BC7-9E71512356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945733"/>
              </p:ext>
            </p:extLst>
          </p:nvPr>
        </p:nvGraphicFramePr>
        <p:xfrm>
          <a:off x="7948" y="5480576"/>
          <a:ext cx="3367379" cy="28545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4D6CB4C9-E4EE-405C-9EB8-961AAD543C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3291083"/>
              </p:ext>
            </p:extLst>
          </p:nvPr>
        </p:nvGraphicFramePr>
        <p:xfrm>
          <a:off x="3410967" y="370284"/>
          <a:ext cx="3349256" cy="25721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02754C8B-EE66-4381-837F-506E9004AE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4956591"/>
              </p:ext>
            </p:extLst>
          </p:nvPr>
        </p:nvGraphicFramePr>
        <p:xfrm>
          <a:off x="3375327" y="2894925"/>
          <a:ext cx="3384896" cy="2692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94A50195-66BA-421A-9BDE-CE9C949358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5891565"/>
              </p:ext>
            </p:extLst>
          </p:nvPr>
        </p:nvGraphicFramePr>
        <p:xfrm>
          <a:off x="3430988" y="5533587"/>
          <a:ext cx="3351474" cy="2849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148715" y="295684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148715" y="2969289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148716" y="5642894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462049" y="312228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491787" y="2969289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491787" y="5626350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38098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98</TotalTime>
  <Words>109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rdia New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DELL</cp:lastModifiedBy>
  <cp:revision>423</cp:revision>
  <dcterms:created xsi:type="dcterms:W3CDTF">2019-11-18T02:47:29Z</dcterms:created>
  <dcterms:modified xsi:type="dcterms:W3CDTF">2021-05-29T08:33:20Z</dcterms:modified>
</cp:coreProperties>
</file>